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F1F1"/>
    <a:srgbClr val="00F8F8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52"/>
    <p:restoredTop sz="95794"/>
  </p:normalViewPr>
  <p:slideViewPr>
    <p:cSldViewPr snapToGrid="0" snapToObjects="1">
      <p:cViewPr varScale="1">
        <p:scale>
          <a:sx n="106" d="100"/>
          <a:sy n="106" d="100"/>
        </p:scale>
        <p:origin x="696" y="176"/>
      </p:cViewPr>
      <p:guideLst/>
    </p:cSldViewPr>
  </p:slideViewPr>
  <p:notesTextViewPr>
    <p:cViewPr>
      <p:scale>
        <a:sx n="105" d="100"/>
        <a:sy n="10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6043E6-5288-1C4A-AE46-87E99E423894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160EB-670F-8345-B3A6-1794A808C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153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8160EB-670F-8345-B3A6-1794A808C03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1523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44AC4-F4EE-1D48-B741-38E5365DC9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48E4B-7419-0846-8CE8-89F36B1079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59" indent="0" algn="ctr">
              <a:buNone/>
              <a:defRPr sz="2000"/>
            </a:lvl2pPr>
            <a:lvl3pPr marL="914317" indent="0" algn="ctr">
              <a:buNone/>
              <a:defRPr sz="1800"/>
            </a:lvl3pPr>
            <a:lvl4pPr marL="1371475" indent="0" algn="ctr">
              <a:buNone/>
              <a:defRPr sz="1600"/>
            </a:lvl4pPr>
            <a:lvl5pPr marL="1828633" indent="0" algn="ctr">
              <a:buNone/>
              <a:defRPr sz="1600"/>
            </a:lvl5pPr>
            <a:lvl6pPr marL="2285792" indent="0" algn="ctr">
              <a:buNone/>
              <a:defRPr sz="1600"/>
            </a:lvl6pPr>
            <a:lvl7pPr marL="2742950" indent="0" algn="ctr">
              <a:buNone/>
              <a:defRPr sz="1600"/>
            </a:lvl7pPr>
            <a:lvl8pPr marL="3200109" indent="0" algn="ctr">
              <a:buNone/>
              <a:defRPr sz="1600"/>
            </a:lvl8pPr>
            <a:lvl9pPr marL="365726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D4DF2-B1E2-1642-BB26-F58A61526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E6B35-4FD3-9546-8203-C9B4BCCC2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647D0-8EE6-A04A-A04A-548385D9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9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4E37BA-F3E2-B946-86B1-6D35A8DBD9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9CCFF5-9DCB-0E4D-9D8D-FD23D7DCCC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0A60D-9037-6347-AC84-13EE355B1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8C037-6238-9E46-B6F6-B6D11F751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85A0C-CEB4-B440-ADA4-360FD4A29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354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A0348A-D30F-9F4C-80DD-5FECEEF559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69ACAF-8EC7-DA46-B534-98B0A04AAD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6EC88-27D5-4E45-A8CC-B7E2E0AD3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66E07-85FD-1440-94EC-B529682EA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558C4-CA96-DA4E-A967-14DF4CBE8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417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70DC9-E69E-5144-83CE-3A1023D9D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B62D8-AF3E-0C43-BAB7-ACC72FE29B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FB05A-1E5E-9C41-9C9A-7D4E6DCEE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7F709-90CF-5340-83B3-B426A9523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3E048-C1AB-4E4D-9345-304BF7D6C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864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C2B3E-83AE-C846-A2E0-F5CC43C94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ADB7CF-0EAD-2C4D-A503-24CEAE97A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5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7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7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2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07AB38-0EE9-BC4A-B1B0-E320509C8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697E7-F1BC-4B43-8649-B015D9933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7677E-5322-B446-92CD-FB9688366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05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B55CC-8881-3F46-991C-6D4772FD5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0FEE5-D3C1-B149-9CA2-B3CF048D7F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098F95-8E8F-394A-BBF0-A85AFA34B4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E87170-B37D-BC40-AF11-C389FAF45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67C4A-7E1F-D14F-9A25-3CC053EF7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7E756B-FCCB-5B47-83F2-8E48EBFF5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9CCF7-600C-804A-84A2-CE71F7A36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A99785-E40A-F94C-8819-F5D9A468E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E320B0-2F9F-7F41-A913-E8A30E31E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DF583F-6263-E949-A1ED-13A6409FC1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11D22-8267-4347-93BA-EB444C5238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E2CD6F-8596-5E41-8C2A-5BB0129A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734ADA-1212-944D-B678-BC7FBB4A1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E11094-D6CC-944E-9620-5F382BF28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1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72947-DC83-A845-9B52-2BBCCD4B4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9217B5-5EB0-4042-9894-169DEB8B6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F03C26-0CFD-C74D-BBD3-CC05F890F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A37C49-8EA1-5149-A2A1-639858B0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370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60A0C3-5DD8-1440-94EC-FD58F656F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FED5B7-710D-3948-A136-463B3E73F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9A8AB0-4947-8D4D-B1D3-AD86B0A52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718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5AEBB-DB81-9F4F-8CE2-0E9FFA3230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6B17BE-9150-0B45-BEA2-435E64EA62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CA32BC-22A2-D34A-8C2B-998003E3A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4ED1B9-4D65-6E4F-9235-85EFE1235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CB5C12-E24A-7C4F-BB70-6C027A23E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FD416-D51C-444C-9181-DDF53856A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04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336F4-2FC4-BF43-885C-70A5DDCCA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B9E8A1-2767-C243-90FF-10BF90E495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59" indent="0">
              <a:buNone/>
              <a:defRPr sz="2799"/>
            </a:lvl2pPr>
            <a:lvl3pPr marL="914317" indent="0">
              <a:buNone/>
              <a:defRPr sz="2400"/>
            </a:lvl3pPr>
            <a:lvl4pPr marL="1371475" indent="0">
              <a:buNone/>
              <a:defRPr sz="2000"/>
            </a:lvl4pPr>
            <a:lvl5pPr marL="1828633" indent="0">
              <a:buNone/>
              <a:defRPr sz="2000"/>
            </a:lvl5pPr>
            <a:lvl6pPr marL="2285792" indent="0">
              <a:buNone/>
              <a:defRPr sz="2000"/>
            </a:lvl6pPr>
            <a:lvl7pPr marL="2742950" indent="0">
              <a:buNone/>
              <a:defRPr sz="2000"/>
            </a:lvl7pPr>
            <a:lvl8pPr marL="3200109" indent="0">
              <a:buNone/>
              <a:defRPr sz="2000"/>
            </a:lvl8pPr>
            <a:lvl9pPr marL="365726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9ABC7-A3F0-B744-9EB6-FD5E933E93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24A8E1-5735-8F40-93D3-DCD3F6779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2EF681-6118-5D4E-B6C5-6F80B03F6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DE7514-D013-2544-B42C-154550847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58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DAF07A-5396-E142-9680-69B49FA8A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A3D35D-179B-8943-A746-CD9C4A1D47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7DD8D-41DC-7448-B6B6-A2F9CC7830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B3B90-C74D-A744-B6C6-FBB917305C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71DAA-C07E-534B-9752-B62B0D3346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60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1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79" indent="-228579" algn="l" defTabSz="91431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37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9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54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13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71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29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88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4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1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75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33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92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5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0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6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535221AA-EA36-D242-9E2C-49E8E10E41CA}"/>
              </a:ext>
            </a:extLst>
          </p:cNvPr>
          <p:cNvSpPr txBox="1"/>
          <p:nvPr/>
        </p:nvSpPr>
        <p:spPr>
          <a:xfrm>
            <a:off x="159657" y="174172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5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0D28454-89B3-DC80-9689-A557301FD0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3257348"/>
              </p:ext>
            </p:extLst>
          </p:nvPr>
        </p:nvGraphicFramePr>
        <p:xfrm>
          <a:off x="276726" y="806116"/>
          <a:ext cx="11670627" cy="5732670"/>
        </p:xfrm>
        <a:graphic>
          <a:graphicData uri="http://schemas.openxmlformats.org/drawingml/2006/table">
            <a:tbl>
              <a:tblPr/>
              <a:tblGrid>
                <a:gridCol w="1230244">
                  <a:extLst>
                    <a:ext uri="{9D8B030D-6E8A-4147-A177-3AD203B41FA5}">
                      <a16:colId xmlns:a16="http://schemas.microsoft.com/office/drawing/2014/main" val="3000136806"/>
                    </a:ext>
                  </a:extLst>
                </a:gridCol>
                <a:gridCol w="1173024">
                  <a:extLst>
                    <a:ext uri="{9D8B030D-6E8A-4147-A177-3AD203B41FA5}">
                      <a16:colId xmlns:a16="http://schemas.microsoft.com/office/drawing/2014/main" val="2650464928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3241971351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2107743889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1297970124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3142648701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3385083210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554208479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2566226634"/>
                    </a:ext>
                  </a:extLst>
                </a:gridCol>
                <a:gridCol w="536443">
                  <a:extLst>
                    <a:ext uri="{9D8B030D-6E8A-4147-A177-3AD203B41FA5}">
                      <a16:colId xmlns:a16="http://schemas.microsoft.com/office/drawing/2014/main" val="1893700452"/>
                    </a:ext>
                  </a:extLst>
                </a:gridCol>
                <a:gridCol w="619890">
                  <a:extLst>
                    <a:ext uri="{9D8B030D-6E8A-4147-A177-3AD203B41FA5}">
                      <a16:colId xmlns:a16="http://schemas.microsoft.com/office/drawing/2014/main" val="3624443846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1566431615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1437295116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4071418083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1070103842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683830984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3493923231"/>
                    </a:ext>
                  </a:extLst>
                </a:gridCol>
                <a:gridCol w="622275">
                  <a:extLst>
                    <a:ext uri="{9D8B030D-6E8A-4147-A177-3AD203B41FA5}">
                      <a16:colId xmlns:a16="http://schemas.microsoft.com/office/drawing/2014/main" val="2393156752"/>
                    </a:ext>
                  </a:extLst>
                </a:gridCol>
              </a:tblGrid>
              <a:tr h="22235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ak Strain Value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ystolic Strain Rate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rly Diastolic Strain Rate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e Diastolic Strain Rate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8076120"/>
                  </a:ext>
                </a:extLst>
              </a:tr>
              <a:tr h="41999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(n=25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 (n=43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C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(n=25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 (n=43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C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(n=25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 (n=43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C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 (n=25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 (n=43)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C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6984047"/>
                  </a:ext>
                </a:extLst>
              </a:tr>
              <a:tr h="222351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rcumferential</a:t>
                      </a:r>
                    </a:p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c</a:t>
                      </a:r>
                      <a:r>
                        <a:rPr lang="en-US" sz="1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5±2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8.9±3.8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1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D5A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2±0.2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09±0.2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2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7C07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± 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E0C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1050903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2.6±3.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0.5±4.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1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EA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6±0.2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2±0.3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0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CD5A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± 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BE9D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EE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3329287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.32±5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.49±6.1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7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2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E9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85±0.3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3±0.42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5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7B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 ± 0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 ± 0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9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C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1604220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.16±3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1.30±4.3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2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CE2C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8±0.2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5±0.28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0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2CB9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9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0901293"/>
                  </a:ext>
                </a:extLst>
              </a:tr>
              <a:tr h="222351">
                <a:tc rowSpan="7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itudinal</a:t>
                      </a:r>
                    </a:p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l</a:t>
                      </a:r>
                      <a:r>
                        <a:rPr lang="en-US" sz="1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FW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.23±2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74±2.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5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5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AF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1±0.1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9±0.1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E2C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EE3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9565912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76±2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45±2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6FAF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9±0.1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8±0.16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E6C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EB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3097911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erior S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55±2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00±2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9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6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4E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1±0.1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±0.17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8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1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ED6A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4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02091236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S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73±2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00±2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6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9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FE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±0.1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1±0.1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4C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CF9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4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1431444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.76±2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24±2.7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5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6C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3±0.1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6±0.17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8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DAB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D2A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F6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2828539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erior FW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1.52±2.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36±2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5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5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EE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2±0.1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6±0.1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D6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5E0C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FB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2668983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0.76±1.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9.96±2.2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0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F0E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8±0.1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5±0.1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2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D9B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D2A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EA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6990108"/>
                  </a:ext>
                </a:extLst>
              </a:tr>
              <a:tr h="222351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al</a:t>
                      </a:r>
                    </a:p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r</a:t>
                      </a:r>
                      <a:r>
                        <a:rPr lang="en-US" sz="1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9±12.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0±15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8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CA9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7±1.0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±1.01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5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7C68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4 ± 1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 ± 1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ACE9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1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 ± 0.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FD7A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8797839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6±13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8±14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4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D5A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3±0.8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±1.0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0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9CE9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 ± 1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D7B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0.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0.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AB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24554863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4±12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0±11.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8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D6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9±0.7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±0.54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2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D0A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 ± 1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 ± 1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E0C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 ± 0.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0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DD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0037845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7±11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9±12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7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9CE9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7±0.7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±0.8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C89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 ± 1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D4A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0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0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D5A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865504"/>
                  </a:ext>
                </a:extLst>
              </a:tr>
              <a:tr h="222351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Area</a:t>
                      </a:r>
                    </a:p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r>
                        <a:rPr lang="en-US" sz="10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.6±3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5±4.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D0A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6±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8±0.3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4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D3A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4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6220197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d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.3±4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.3±5.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8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9D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4±0.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3±0.36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8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9CE9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6E0C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5053192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pic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8.6±6.8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5.5±8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7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7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FE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7±0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3±0.57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8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DAB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 ± 0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± 0.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E9D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5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7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A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1335981"/>
                  </a:ext>
                </a:extLst>
              </a:tr>
              <a:tr h="22235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obal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6±4.1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0.1±5.6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19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±0.3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±0.35*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AC88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4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DCB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3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5817063"/>
                  </a:ext>
                </a:extLst>
              </a:tr>
              <a:tr h="222351">
                <a:tc gridSpan="18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W - free-wall; S - septal; Ctrl - healthy control; DMD CM - Duchenne muscular dystrophy- associated cardiomyopathy; AUC - area under the curve. *</a:t>
                      </a: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5 </a:t>
                      </a:r>
                    </a:p>
                  </a:txBody>
                  <a:tcPr marL="6513" marR="6513" marT="6513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1F1F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17422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04553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389</TotalTime>
  <Words>713</Words>
  <Application>Microsoft Macintosh PowerPoint</Application>
  <PresentationFormat>Widescreen</PresentationFormat>
  <Paragraphs>35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r Earl</dc:creator>
  <cp:lastModifiedBy>Conner Earl</cp:lastModifiedBy>
  <cp:revision>61</cp:revision>
  <cp:lastPrinted>2022-02-06T03:55:09Z</cp:lastPrinted>
  <dcterms:created xsi:type="dcterms:W3CDTF">2022-01-21T23:01:07Z</dcterms:created>
  <dcterms:modified xsi:type="dcterms:W3CDTF">2022-10-27T13:46:11Z</dcterms:modified>
</cp:coreProperties>
</file>